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8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624" autoAdjust="0"/>
    <p:restoredTop sz="78846" autoAdjust="0"/>
  </p:normalViewPr>
  <p:slideViewPr>
    <p:cSldViewPr snapToGrid="0" snapToObjects="1">
      <p:cViewPr>
        <p:scale>
          <a:sx n="130" d="100"/>
          <a:sy n="130" d="100"/>
        </p:scale>
        <p:origin x="-968" y="-3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:Desktop:predict_causual_genes:feature_selection:AT%20LOO_AUC_reduc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:Desktop:predict_causual_genes:feature_selection:rice%20LOO_AUC_reduc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69336028942328"/>
          <c:y val="0.0472361809045226"/>
          <c:w val="0.880093424132794"/>
          <c:h val="0.1595706749341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LOO_AUC_reduction.txt!$B$1</c:f>
              <c:strCache>
                <c:ptCount val="1"/>
                <c:pt idx="0">
                  <c:v>ROC-AUC change</c:v>
                </c:pt>
              </c:strCache>
            </c:strRef>
          </c:tx>
          <c:spPr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229:$C$260</c:f>
                <c:numCache>
                  <c:formatCode>General</c:formatCode>
                  <c:ptCount val="32"/>
                  <c:pt idx="0">
                    <c:v>0.00977340461225716</c:v>
                  </c:pt>
                  <c:pt idx="1">
                    <c:v>0.00613043428153281</c:v>
                  </c:pt>
                  <c:pt idx="2">
                    <c:v>0.00588643317717449</c:v>
                  </c:pt>
                  <c:pt idx="3">
                    <c:v>0.00363652442584591</c:v>
                  </c:pt>
                  <c:pt idx="4">
                    <c:v>0.00377323354696334</c:v>
                  </c:pt>
                  <c:pt idx="5">
                    <c:v>0.00357487488001062</c:v>
                  </c:pt>
                  <c:pt idx="6">
                    <c:v>0.00190016519180598</c:v>
                  </c:pt>
                  <c:pt idx="7">
                    <c:v>0.00245212064998418</c:v>
                  </c:pt>
                  <c:pt idx="8">
                    <c:v>0.00186663120636873</c:v>
                  </c:pt>
                  <c:pt idx="9">
                    <c:v>0.00115585508425443</c:v>
                  </c:pt>
                  <c:pt idx="10">
                    <c:v>0.00140651501929983</c:v>
                  </c:pt>
                  <c:pt idx="11">
                    <c:v>0.00106173852740648</c:v>
                  </c:pt>
                  <c:pt idx="12">
                    <c:v>0.00104848083675426</c:v>
                  </c:pt>
                  <c:pt idx="13">
                    <c:v>0.00110159092617555</c:v>
                  </c:pt>
                  <c:pt idx="14">
                    <c:v>0.00091986526701759</c:v>
                  </c:pt>
                  <c:pt idx="15">
                    <c:v>0.00130136804454812</c:v>
                  </c:pt>
                  <c:pt idx="16">
                    <c:v>0.00128209830500585</c:v>
                  </c:pt>
                  <c:pt idx="17">
                    <c:v>0.00228020225124937</c:v>
                  </c:pt>
                  <c:pt idx="18">
                    <c:v>0.00120307907377562</c:v>
                  </c:pt>
                  <c:pt idx="19">
                    <c:v>0.00129352800687085</c:v>
                  </c:pt>
                  <c:pt idx="20">
                    <c:v>0.00116150637668246</c:v>
                  </c:pt>
                  <c:pt idx="21">
                    <c:v>0.00107857900682854</c:v>
                  </c:pt>
                  <c:pt idx="22">
                    <c:v>0.00167678743463535</c:v>
                  </c:pt>
                  <c:pt idx="23">
                    <c:v>0.00114189164012364</c:v>
                  </c:pt>
                  <c:pt idx="24">
                    <c:v>0.0010551234401609</c:v>
                  </c:pt>
                  <c:pt idx="25">
                    <c:v>0.0013552102147394</c:v>
                  </c:pt>
                  <c:pt idx="26">
                    <c:v>0.00120837773639105</c:v>
                  </c:pt>
                  <c:pt idx="27">
                    <c:v>0.00220593730184082</c:v>
                  </c:pt>
                  <c:pt idx="28">
                    <c:v>0.00258550930379798</c:v>
                  </c:pt>
                  <c:pt idx="29">
                    <c:v>0.0053418355162367</c:v>
                  </c:pt>
                  <c:pt idx="30">
                    <c:v>0.00237247986763009</c:v>
                  </c:pt>
                  <c:pt idx="31">
                    <c:v>0.00443539431021464</c:v>
                  </c:pt>
                </c:numCache>
              </c:numRef>
            </c:plus>
            <c:minus>
              <c:numRef>
                <c:f>Sheet1!$C$229:$C$260</c:f>
                <c:numCache>
                  <c:formatCode>General</c:formatCode>
                  <c:ptCount val="32"/>
                  <c:pt idx="0">
                    <c:v>0.00977340461225716</c:v>
                  </c:pt>
                  <c:pt idx="1">
                    <c:v>0.00613043428153281</c:v>
                  </c:pt>
                  <c:pt idx="2">
                    <c:v>0.00588643317717449</c:v>
                  </c:pt>
                  <c:pt idx="3">
                    <c:v>0.00363652442584591</c:v>
                  </c:pt>
                  <c:pt idx="4">
                    <c:v>0.00377323354696334</c:v>
                  </c:pt>
                  <c:pt idx="5">
                    <c:v>0.00357487488001062</c:v>
                  </c:pt>
                  <c:pt idx="6">
                    <c:v>0.00190016519180598</c:v>
                  </c:pt>
                  <c:pt idx="7">
                    <c:v>0.00245212064998418</c:v>
                  </c:pt>
                  <c:pt idx="8">
                    <c:v>0.00186663120636873</c:v>
                  </c:pt>
                  <c:pt idx="9">
                    <c:v>0.00115585508425443</c:v>
                  </c:pt>
                  <c:pt idx="10">
                    <c:v>0.00140651501929983</c:v>
                  </c:pt>
                  <c:pt idx="11">
                    <c:v>0.00106173852740648</c:v>
                  </c:pt>
                  <c:pt idx="12">
                    <c:v>0.00104848083675426</c:v>
                  </c:pt>
                  <c:pt idx="13">
                    <c:v>0.00110159092617555</c:v>
                  </c:pt>
                  <c:pt idx="14">
                    <c:v>0.00091986526701759</c:v>
                  </c:pt>
                  <c:pt idx="15">
                    <c:v>0.00130136804454812</c:v>
                  </c:pt>
                  <c:pt idx="16">
                    <c:v>0.00128209830500585</c:v>
                  </c:pt>
                  <c:pt idx="17">
                    <c:v>0.00228020225124937</c:v>
                  </c:pt>
                  <c:pt idx="18">
                    <c:v>0.00120307907377562</c:v>
                  </c:pt>
                  <c:pt idx="19">
                    <c:v>0.00129352800687085</c:v>
                  </c:pt>
                  <c:pt idx="20">
                    <c:v>0.00116150637668246</c:v>
                  </c:pt>
                  <c:pt idx="21">
                    <c:v>0.00107857900682854</c:v>
                  </c:pt>
                  <c:pt idx="22">
                    <c:v>0.00167678743463535</c:v>
                  </c:pt>
                  <c:pt idx="23">
                    <c:v>0.00114189164012364</c:v>
                  </c:pt>
                  <c:pt idx="24">
                    <c:v>0.0010551234401609</c:v>
                  </c:pt>
                  <c:pt idx="25">
                    <c:v>0.0013552102147394</c:v>
                  </c:pt>
                  <c:pt idx="26">
                    <c:v>0.00120837773639105</c:v>
                  </c:pt>
                  <c:pt idx="27">
                    <c:v>0.00220593730184082</c:v>
                  </c:pt>
                  <c:pt idx="28">
                    <c:v>0.00258550930379798</c:v>
                  </c:pt>
                  <c:pt idx="29">
                    <c:v>0.0053418355162367</c:v>
                  </c:pt>
                  <c:pt idx="30">
                    <c:v>0.00237247986763009</c:v>
                  </c:pt>
                  <c:pt idx="31">
                    <c:v>0.00443539431021464</c:v>
                  </c:pt>
                </c:numCache>
              </c:numRef>
            </c:minus>
          </c:errBars>
          <c:cat>
            <c:strRef>
              <c:f>Sheet1!$A$266:$A$297</c:f>
              <c:strCache>
                <c:ptCount val="32"/>
                <c:pt idx="0">
                  <c:v>paralog_copy_number</c:v>
                </c:pt>
                <c:pt idx="1">
                  <c:v>is_TF</c:v>
                </c:pt>
                <c:pt idx="2">
                  <c:v>is_specialized_metabolism</c:v>
                </c:pt>
                <c:pt idx="3">
                  <c:v>CE_snp</c:v>
                </c:pt>
                <c:pt idx="4">
                  <c:v>normalized_nonsyn_SNP</c:v>
                </c:pt>
                <c:pt idx="5">
                  <c:v>network_weight</c:v>
                </c:pt>
                <c:pt idx="6">
                  <c:v>is_receptor</c:v>
                </c:pt>
                <c:pt idx="7">
                  <c:v>is_hormones_metabolism</c:v>
                </c:pt>
                <c:pt idx="8">
                  <c:v>is_carbohydrates_metabolism</c:v>
                </c:pt>
                <c:pt idx="9">
                  <c:v>is_inorganic_nutrients_metabolism</c:v>
                </c:pt>
                <c:pt idx="10">
                  <c:v>is_macromolecule_metabolism</c:v>
                </c:pt>
                <c:pt idx="11">
                  <c:v>is_transporter</c:v>
                </c:pt>
                <c:pt idx="12">
                  <c:v>is_cofactors_metabolism</c:v>
                </c:pt>
                <c:pt idx="13">
                  <c:v>is_essential_gene</c:v>
                </c:pt>
                <c:pt idx="14">
                  <c:v>is_nonsyn_deleterious</c:v>
                </c:pt>
                <c:pt idx="15">
                  <c:v>is_kinase</c:v>
                </c:pt>
                <c:pt idx="16">
                  <c:v>is_fatty_acids_lipids_metabolism</c:v>
                </c:pt>
                <c:pt idx="17">
                  <c:v>is_splice_site_SNP</c:v>
                </c:pt>
                <c:pt idx="18">
                  <c:v>is_energy_metabolism</c:v>
                </c:pt>
                <c:pt idx="19">
                  <c:v>TFBS_indel</c:v>
                </c:pt>
                <c:pt idx="20">
                  <c:v>is_other_metabolism</c:v>
                </c:pt>
                <c:pt idx="21">
                  <c:v>is_stop_gained</c:v>
                </c:pt>
                <c:pt idx="22">
                  <c:v>is_redox_metabolism</c:v>
                </c:pt>
                <c:pt idx="23">
                  <c:v>is_detoxification_metabolism</c:v>
                </c:pt>
                <c:pt idx="24">
                  <c:v>is_stop_lost</c:v>
                </c:pt>
                <c:pt idx="25">
                  <c:v>is_amino_acids_metabolism</c:v>
                </c:pt>
                <c:pt idx="26">
                  <c:v>is_nucleotides_metabolism</c:v>
                </c:pt>
                <c:pt idx="27">
                  <c:v>is_start_lost</c:v>
                </c:pt>
                <c:pt idx="28">
                  <c:v>percent_absence</c:v>
                </c:pt>
                <c:pt idx="29">
                  <c:v>TFBS_snp</c:v>
                </c:pt>
                <c:pt idx="30">
                  <c:v>CE_indel</c:v>
                </c:pt>
                <c:pt idx="31">
                  <c:v>is_start_gained</c:v>
                </c:pt>
              </c:strCache>
            </c:strRef>
          </c:cat>
          <c:val>
            <c:numRef>
              <c:f>Sheet1!$B$266:$B$297</c:f>
              <c:numCache>
                <c:formatCode>General</c:formatCode>
                <c:ptCount val="32"/>
                <c:pt idx="0">
                  <c:v>-0.0502608287319378</c:v>
                </c:pt>
                <c:pt idx="1">
                  <c:v>-0.0200829245845891</c:v>
                </c:pt>
                <c:pt idx="2">
                  <c:v>-0.010783713453004</c:v>
                </c:pt>
                <c:pt idx="3">
                  <c:v>-0.00639037511134403</c:v>
                </c:pt>
                <c:pt idx="4">
                  <c:v>-0.00609041630638639</c:v>
                </c:pt>
                <c:pt idx="5">
                  <c:v>-0.00608749554605149</c:v>
                </c:pt>
                <c:pt idx="6">
                  <c:v>-0.00528463603954592</c:v>
                </c:pt>
                <c:pt idx="7">
                  <c:v>-0.00519365802230073</c:v>
                </c:pt>
                <c:pt idx="8">
                  <c:v>-0.00511619591730318</c:v>
                </c:pt>
                <c:pt idx="9">
                  <c:v>-0.00436643748981735</c:v>
                </c:pt>
                <c:pt idx="10">
                  <c:v>-0.00327511786560747</c:v>
                </c:pt>
                <c:pt idx="11">
                  <c:v>-0.00280722278090957</c:v>
                </c:pt>
                <c:pt idx="12">
                  <c:v>-0.00205774308913862</c:v>
                </c:pt>
                <c:pt idx="13">
                  <c:v>-0.00124239325399448</c:v>
                </c:pt>
                <c:pt idx="14">
                  <c:v>-0.00108034137033754</c:v>
                </c:pt>
                <c:pt idx="15">
                  <c:v>-0.000868147538313362</c:v>
                </c:pt>
                <c:pt idx="16">
                  <c:v>-0.000631912895658185</c:v>
                </c:pt>
                <c:pt idx="17">
                  <c:v>-0.000296366603970779</c:v>
                </c:pt>
                <c:pt idx="18">
                  <c:v>-0.000192824246813757</c:v>
                </c:pt>
                <c:pt idx="19" formatCode="0.00E+00">
                  <c:v>2.77924917515845E-5</c:v>
                </c:pt>
                <c:pt idx="20" formatCode="0.00E+00">
                  <c:v>6.82490236273422E-5</c:v>
                </c:pt>
                <c:pt idx="21">
                  <c:v>0.000210574482354248</c:v>
                </c:pt>
                <c:pt idx="22">
                  <c:v>0.000256522815914653</c:v>
                </c:pt>
                <c:pt idx="23">
                  <c:v>0.000617628402915577</c:v>
                </c:pt>
                <c:pt idx="24">
                  <c:v>0.000629632368546601</c:v>
                </c:pt>
                <c:pt idx="25">
                  <c:v>0.00110648377637128</c:v>
                </c:pt>
                <c:pt idx="26">
                  <c:v>0.001296583389277</c:v>
                </c:pt>
                <c:pt idx="27">
                  <c:v>0.00132085596166992</c:v>
                </c:pt>
                <c:pt idx="28">
                  <c:v>0.00180998913557314</c:v>
                </c:pt>
                <c:pt idx="29">
                  <c:v>0.00249916343351185</c:v>
                </c:pt>
                <c:pt idx="30">
                  <c:v>0.00290814084624309</c:v>
                </c:pt>
                <c:pt idx="31">
                  <c:v>0.003631776237022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AE0-0845-B7CF-BCF6BFAFC4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1991640"/>
        <c:axId val="-2141433192"/>
      </c:barChart>
      <c:catAx>
        <c:axId val="-214199164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41433192"/>
        <c:crosses val="autoZero"/>
        <c:auto val="1"/>
        <c:lblAlgn val="ctr"/>
        <c:lblOffset val="1000"/>
        <c:noMultiLvlLbl val="0"/>
      </c:catAx>
      <c:valAx>
        <c:axId val="-2141433192"/>
        <c:scaling>
          <c:orientation val="minMax"/>
          <c:max val="0.02"/>
          <c:min val="-0.06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600"/>
                </a:pPr>
                <a:r>
                  <a:rPr lang="en-US" sz="1100" b="1" i="0" baseline="0" dirty="0">
                    <a:effectLst/>
                  </a:rPr>
                  <a:t>AUC-ROC change</a:t>
                </a:r>
                <a:endParaRPr lang="en-US" sz="6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0913641369331087"/>
              <c:y val="0.0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-2141991640"/>
        <c:crosses val="autoZero"/>
        <c:crossBetween val="between"/>
        <c:majorUnit val="0.02"/>
      </c:valAx>
      <c:spPr>
        <a:ln>
          <a:solidFill>
            <a:srgbClr val="000000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69336028942328"/>
          <c:y val="0.0472361809045226"/>
          <c:w val="0.880093424132794"/>
          <c:h val="0.2311248899400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AT LOO_AUC_reduction.xlsx]LOO_AUC_reduction.txt'!$B$1</c:f>
              <c:strCache>
                <c:ptCount val="1"/>
                <c:pt idx="0">
                  <c:v>ROC-AUC change</c:v>
                </c:pt>
              </c:strCache>
            </c:strRef>
          </c:tx>
          <c:spPr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AT LOO_AUC_reduction.xlsx]Sheet1'!$C$229:$C$260</c:f>
                <c:numCache>
                  <c:formatCode>General</c:formatCode>
                  <c:ptCount val="32"/>
                  <c:pt idx="0">
                    <c:v>0.00977340461225716</c:v>
                  </c:pt>
                  <c:pt idx="1">
                    <c:v>0.00613043428153281</c:v>
                  </c:pt>
                  <c:pt idx="2">
                    <c:v>0.00588643317717449</c:v>
                  </c:pt>
                  <c:pt idx="3">
                    <c:v>0.00363652442584591</c:v>
                  </c:pt>
                  <c:pt idx="4">
                    <c:v>0.00377323354696334</c:v>
                  </c:pt>
                  <c:pt idx="5">
                    <c:v>0.00357487488001062</c:v>
                  </c:pt>
                  <c:pt idx="6">
                    <c:v>0.00190016519180598</c:v>
                  </c:pt>
                  <c:pt idx="7">
                    <c:v>0.00245212064998418</c:v>
                  </c:pt>
                  <c:pt idx="8">
                    <c:v>0.00186663120636873</c:v>
                  </c:pt>
                  <c:pt idx="9">
                    <c:v>0.00115585508425443</c:v>
                  </c:pt>
                  <c:pt idx="10">
                    <c:v>0.00140651501929983</c:v>
                  </c:pt>
                  <c:pt idx="11">
                    <c:v>0.00106173852740648</c:v>
                  </c:pt>
                  <c:pt idx="12">
                    <c:v>0.00104848083675426</c:v>
                  </c:pt>
                  <c:pt idx="13">
                    <c:v>0.00110159092617555</c:v>
                  </c:pt>
                  <c:pt idx="14">
                    <c:v>0.00091986526701759</c:v>
                  </c:pt>
                  <c:pt idx="15">
                    <c:v>0.00130136804454812</c:v>
                  </c:pt>
                  <c:pt idx="16">
                    <c:v>0.00128209830500585</c:v>
                  </c:pt>
                  <c:pt idx="17">
                    <c:v>0.00228020225124937</c:v>
                  </c:pt>
                  <c:pt idx="18">
                    <c:v>0.00120307907377562</c:v>
                  </c:pt>
                  <c:pt idx="19">
                    <c:v>0.00129352800687085</c:v>
                  </c:pt>
                  <c:pt idx="20">
                    <c:v>0.00116150637668246</c:v>
                  </c:pt>
                  <c:pt idx="21">
                    <c:v>0.00107857900682854</c:v>
                  </c:pt>
                  <c:pt idx="22">
                    <c:v>0.00167678743463535</c:v>
                  </c:pt>
                  <c:pt idx="23">
                    <c:v>0.00114189164012364</c:v>
                  </c:pt>
                  <c:pt idx="24">
                    <c:v>0.0010551234401609</c:v>
                  </c:pt>
                  <c:pt idx="25">
                    <c:v>0.0013552102147394</c:v>
                  </c:pt>
                  <c:pt idx="26">
                    <c:v>0.00120837773639105</c:v>
                  </c:pt>
                  <c:pt idx="27">
                    <c:v>0.00220593730184082</c:v>
                  </c:pt>
                  <c:pt idx="28">
                    <c:v>0.00258550930379798</c:v>
                  </c:pt>
                  <c:pt idx="29">
                    <c:v>0.0053418355162367</c:v>
                  </c:pt>
                  <c:pt idx="30">
                    <c:v>0.00237247986763009</c:v>
                  </c:pt>
                  <c:pt idx="31">
                    <c:v>0.00443539431021464</c:v>
                  </c:pt>
                </c:numCache>
              </c:numRef>
            </c:plus>
            <c:minus>
              <c:numRef>
                <c:f>'[AT LOO_AUC_reduction.xlsx]Sheet1'!$C$229:$C$260</c:f>
                <c:numCache>
                  <c:formatCode>General</c:formatCode>
                  <c:ptCount val="32"/>
                  <c:pt idx="0">
                    <c:v>0.00977340461225716</c:v>
                  </c:pt>
                  <c:pt idx="1">
                    <c:v>0.00613043428153281</c:v>
                  </c:pt>
                  <c:pt idx="2">
                    <c:v>0.00588643317717449</c:v>
                  </c:pt>
                  <c:pt idx="3">
                    <c:v>0.00363652442584591</c:v>
                  </c:pt>
                  <c:pt idx="4">
                    <c:v>0.00377323354696334</c:v>
                  </c:pt>
                  <c:pt idx="5">
                    <c:v>0.00357487488001062</c:v>
                  </c:pt>
                  <c:pt idx="6">
                    <c:v>0.00190016519180598</c:v>
                  </c:pt>
                  <c:pt idx="7">
                    <c:v>0.00245212064998418</c:v>
                  </c:pt>
                  <c:pt idx="8">
                    <c:v>0.00186663120636873</c:v>
                  </c:pt>
                  <c:pt idx="9">
                    <c:v>0.00115585508425443</c:v>
                  </c:pt>
                  <c:pt idx="10">
                    <c:v>0.00140651501929983</c:v>
                  </c:pt>
                  <c:pt idx="11">
                    <c:v>0.00106173852740648</c:v>
                  </c:pt>
                  <c:pt idx="12">
                    <c:v>0.00104848083675426</c:v>
                  </c:pt>
                  <c:pt idx="13">
                    <c:v>0.00110159092617555</c:v>
                  </c:pt>
                  <c:pt idx="14">
                    <c:v>0.00091986526701759</c:v>
                  </c:pt>
                  <c:pt idx="15">
                    <c:v>0.00130136804454812</c:v>
                  </c:pt>
                  <c:pt idx="16">
                    <c:v>0.00128209830500585</c:v>
                  </c:pt>
                  <c:pt idx="17">
                    <c:v>0.00228020225124937</c:v>
                  </c:pt>
                  <c:pt idx="18">
                    <c:v>0.00120307907377562</c:v>
                  </c:pt>
                  <c:pt idx="19">
                    <c:v>0.00129352800687085</c:v>
                  </c:pt>
                  <c:pt idx="20">
                    <c:v>0.00116150637668246</c:v>
                  </c:pt>
                  <c:pt idx="21">
                    <c:v>0.00107857900682854</c:v>
                  </c:pt>
                  <c:pt idx="22">
                    <c:v>0.00167678743463535</c:v>
                  </c:pt>
                  <c:pt idx="23">
                    <c:v>0.00114189164012364</c:v>
                  </c:pt>
                  <c:pt idx="24">
                    <c:v>0.0010551234401609</c:v>
                  </c:pt>
                  <c:pt idx="25">
                    <c:v>0.0013552102147394</c:v>
                  </c:pt>
                  <c:pt idx="26">
                    <c:v>0.00120837773639105</c:v>
                  </c:pt>
                  <c:pt idx="27">
                    <c:v>0.00220593730184082</c:v>
                  </c:pt>
                  <c:pt idx="28">
                    <c:v>0.00258550930379798</c:v>
                  </c:pt>
                  <c:pt idx="29">
                    <c:v>0.0053418355162367</c:v>
                  </c:pt>
                  <c:pt idx="30">
                    <c:v>0.00237247986763009</c:v>
                  </c:pt>
                  <c:pt idx="31">
                    <c:v>0.00443539431021464</c:v>
                  </c:pt>
                </c:numCache>
              </c:numRef>
            </c:minus>
          </c:errBars>
          <c:cat>
            <c:strRef>
              <c:f>Sheet1!$A$215:$A$246</c:f>
              <c:strCache>
                <c:ptCount val="32"/>
                <c:pt idx="0">
                  <c:v>paralog_copy_number</c:v>
                </c:pt>
                <c:pt idx="1">
                  <c:v>is_specialized_metabolism</c:v>
                </c:pt>
                <c:pt idx="2">
                  <c:v>network_weight</c:v>
                </c:pt>
                <c:pt idx="3">
                  <c:v>is_TF</c:v>
                </c:pt>
                <c:pt idx="4">
                  <c:v>is_transporter</c:v>
                </c:pt>
                <c:pt idx="5">
                  <c:v>is_inorganic_nutrients_metabolism</c:v>
                </c:pt>
                <c:pt idx="6">
                  <c:v>is_carbohydrates_metabolism</c:v>
                </c:pt>
                <c:pt idx="7">
                  <c:v>is_receptor</c:v>
                </c:pt>
                <c:pt idx="8">
                  <c:v>is_amino_acids_metabolism</c:v>
                </c:pt>
                <c:pt idx="9">
                  <c:v>is_stop_lost</c:v>
                </c:pt>
                <c:pt idx="10">
                  <c:v>CE_indel</c:v>
                </c:pt>
                <c:pt idx="11">
                  <c:v>is_essential_gene</c:v>
                </c:pt>
                <c:pt idx="12">
                  <c:v>is_kinase</c:v>
                </c:pt>
                <c:pt idx="13">
                  <c:v>is_hormones_metabolism</c:v>
                </c:pt>
                <c:pt idx="14">
                  <c:v>is_energy_metabolism</c:v>
                </c:pt>
                <c:pt idx="15">
                  <c:v>is_nucleotides_metabolism</c:v>
                </c:pt>
                <c:pt idx="16">
                  <c:v>is_splice_site_SNP</c:v>
                </c:pt>
                <c:pt idx="17">
                  <c:v>is_other_metabolism</c:v>
                </c:pt>
                <c:pt idx="18">
                  <c:v>is_fatty_acids_lipids_metabolism</c:v>
                </c:pt>
                <c:pt idx="19">
                  <c:v>is_detoxification_metabolism</c:v>
                </c:pt>
                <c:pt idx="20">
                  <c:v>is_redox_metabolism</c:v>
                </c:pt>
                <c:pt idx="21">
                  <c:v>is_nonsyn_deleterious</c:v>
                </c:pt>
                <c:pt idx="22">
                  <c:v>is_start_lost</c:v>
                </c:pt>
                <c:pt idx="23">
                  <c:v>is_macromolecule_metabolism</c:v>
                </c:pt>
                <c:pt idx="24">
                  <c:v>TFBS_snp</c:v>
                </c:pt>
                <c:pt idx="25">
                  <c:v>is_cofactors_metabolism</c:v>
                </c:pt>
                <c:pt idx="26">
                  <c:v>is_start_gained</c:v>
                </c:pt>
                <c:pt idx="27">
                  <c:v>TFBS_indel</c:v>
                </c:pt>
                <c:pt idx="28">
                  <c:v>is_stop_gained</c:v>
                </c:pt>
                <c:pt idx="29">
                  <c:v>CE_snp</c:v>
                </c:pt>
                <c:pt idx="30">
                  <c:v>normalized_nonsyn_SNP</c:v>
                </c:pt>
                <c:pt idx="31">
                  <c:v>percent_absence</c:v>
                </c:pt>
              </c:strCache>
            </c:strRef>
          </c:cat>
          <c:val>
            <c:numRef>
              <c:f>Sheet1!$B$215:$B$246</c:f>
              <c:numCache>
                <c:formatCode>General</c:formatCode>
                <c:ptCount val="32"/>
                <c:pt idx="0">
                  <c:v>-0.076898743081864</c:v>
                </c:pt>
                <c:pt idx="1">
                  <c:v>-0.0181860193595261</c:v>
                </c:pt>
                <c:pt idx="2">
                  <c:v>-0.00749620604155675</c:v>
                </c:pt>
                <c:pt idx="3">
                  <c:v>-0.00734355979184599</c:v>
                </c:pt>
                <c:pt idx="4">
                  <c:v>-0.00543878227433013</c:v>
                </c:pt>
                <c:pt idx="5">
                  <c:v>-0.00310478709445138</c:v>
                </c:pt>
                <c:pt idx="6">
                  <c:v>-0.00245463617122495</c:v>
                </c:pt>
                <c:pt idx="7">
                  <c:v>-0.00171944790087463</c:v>
                </c:pt>
                <c:pt idx="8">
                  <c:v>-0.0011903649190615</c:v>
                </c:pt>
                <c:pt idx="9">
                  <c:v>-0.00107938195270489</c:v>
                </c:pt>
                <c:pt idx="10">
                  <c:v>-0.000922002376787447</c:v>
                </c:pt>
                <c:pt idx="11">
                  <c:v>-0.000859419417187281</c:v>
                </c:pt>
                <c:pt idx="12">
                  <c:v>-0.000686685457170624</c:v>
                </c:pt>
                <c:pt idx="13">
                  <c:v>-0.000686295910130038</c:v>
                </c:pt>
                <c:pt idx="14">
                  <c:v>-0.000373201154056181</c:v>
                </c:pt>
                <c:pt idx="15">
                  <c:v>-0.000354405189596927</c:v>
                </c:pt>
                <c:pt idx="16" formatCode="0.00E+00">
                  <c:v>-9.3284548752835E-5</c:v>
                </c:pt>
                <c:pt idx="17" formatCode="0.00E+00">
                  <c:v>-8.55893905317221E-5</c:v>
                </c:pt>
                <c:pt idx="18">
                  <c:v>0.000201741270951919</c:v>
                </c:pt>
                <c:pt idx="19">
                  <c:v>0.00031530182858994</c:v>
                </c:pt>
                <c:pt idx="20">
                  <c:v>0.000360117216437596</c:v>
                </c:pt>
                <c:pt idx="21">
                  <c:v>0.000438724796612523</c:v>
                </c:pt>
                <c:pt idx="22">
                  <c:v>0.000440156357628765</c:v>
                </c:pt>
                <c:pt idx="23">
                  <c:v>0.000630223877088249</c:v>
                </c:pt>
                <c:pt idx="24">
                  <c:v>0.000718737748900921</c:v>
                </c:pt>
                <c:pt idx="25">
                  <c:v>0.000808503634504143</c:v>
                </c:pt>
                <c:pt idx="26">
                  <c:v>0.000852377424499051</c:v>
                </c:pt>
                <c:pt idx="27">
                  <c:v>0.00112375423610532</c:v>
                </c:pt>
                <c:pt idx="28">
                  <c:v>0.00314523448165116</c:v>
                </c:pt>
                <c:pt idx="29">
                  <c:v>0.00349819199305844</c:v>
                </c:pt>
                <c:pt idx="30">
                  <c:v>0.00405192644509232</c:v>
                </c:pt>
                <c:pt idx="31">
                  <c:v>0.004085928169281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F54-5E4C-9B62-047350BA95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0006584"/>
        <c:axId val="-2125724072"/>
      </c:barChart>
      <c:catAx>
        <c:axId val="-214000658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25724072"/>
        <c:crosses val="autoZero"/>
        <c:auto val="1"/>
        <c:lblAlgn val="ctr"/>
        <c:lblOffset val="1000"/>
        <c:noMultiLvlLbl val="0"/>
      </c:catAx>
      <c:valAx>
        <c:axId val="-2125724072"/>
        <c:scaling>
          <c:orientation val="minMax"/>
          <c:max val="0.02"/>
          <c:min val="-0.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600"/>
                </a:pPr>
                <a:r>
                  <a:rPr lang="en-US" sz="1100" b="1" i="0" baseline="0" dirty="0">
                    <a:effectLst/>
                  </a:rPr>
                  <a:t>AUC-ROC change</a:t>
                </a:r>
                <a:endParaRPr lang="en-US" sz="6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0106471603056299"/>
              <c:y val="0.0020126541052654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-2140006584"/>
        <c:crosses val="autoZero"/>
        <c:crossBetween val="between"/>
        <c:majorUnit val="0.04"/>
      </c:valAx>
      <c:spPr>
        <a:ln>
          <a:solidFill>
            <a:srgbClr val="000000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EB0E04-CF10-0E4A-B177-F58404C5BA82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A18E88-A819-0540-8060-A0CBAB93035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576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A18E88-A819-0540-8060-A0CBAB93035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78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9F149E-FA5B-474C-AE18-C13289586223}" type="datetimeFigureOut">
              <a:rPr lang="en-US" smtClean="0"/>
              <a:pPr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8B0AB-FBE0-F04A-AEDE-43F19F0EFBD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Table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63377652"/>
              </p:ext>
            </p:extLst>
          </p:nvPr>
        </p:nvGraphicFramePr>
        <p:xfrm>
          <a:off x="1091309" y="4133088"/>
          <a:ext cx="7598656" cy="1925071"/>
        </p:xfrm>
        <a:graphic>
          <a:graphicData uri="http://schemas.openxmlformats.org/drawingml/2006/table">
            <a:tbl>
              <a:tblPr/>
              <a:tblGrid>
                <a:gridCol w="23745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237458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</a:tblGrid>
              <a:tr h="1925071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paralog_copy_number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specialized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network_weight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TF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transporter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inorganic_nutrient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carbohydrate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receptor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amino_acid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stop_lost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CE_indel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essential_gene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kinase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hormone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energy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nucleotide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splice_site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other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fatty_acid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detoxification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redox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nonsyn_deleterious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start_lost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macromolecule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TFBS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cofactor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start_garined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TFBS_indel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stop_garined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CE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normalized_nonsyn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percent_absence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2256443"/>
              </p:ext>
            </p:extLst>
          </p:nvPr>
        </p:nvGraphicFramePr>
        <p:xfrm>
          <a:off x="255609" y="626877"/>
          <a:ext cx="8682838" cy="2792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883110" y="375385"/>
            <a:ext cx="12813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rabidopsis</a:t>
            </a: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3670667"/>
              </p:ext>
            </p:extLst>
          </p:nvPr>
        </p:nvGraphicFramePr>
        <p:xfrm>
          <a:off x="234369" y="3386363"/>
          <a:ext cx="8635542" cy="24594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1" name="Straight Arrow Connector 10"/>
          <p:cNvCxnSpPr/>
          <p:nvPr/>
        </p:nvCxnSpPr>
        <p:spPr>
          <a:xfrm flipV="1">
            <a:off x="8122697" y="1856986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V="1">
            <a:off x="8372785" y="1773289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flipV="1">
            <a:off x="3569696" y="4672867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V="1">
            <a:off x="5755087" y="1975034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 flipV="1">
            <a:off x="1917721" y="1800378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V="1">
            <a:off x="7891537" y="2300824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flipV="1">
            <a:off x="6874292" y="4734474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V="1">
            <a:off x="7605519" y="4845224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/>
          <p:cNvCxnSpPr/>
          <p:nvPr/>
        </p:nvCxnSpPr>
        <p:spPr>
          <a:xfrm flipV="1">
            <a:off x="8064739" y="4650970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 flipV="1">
            <a:off x="8537149" y="5235141"/>
            <a:ext cx="0" cy="236097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150635" y="3158813"/>
            <a:ext cx="5305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</a:t>
            </a:r>
            <a:r>
              <a:rPr lang="en-US" dirty="0" smtClean="0"/>
              <a:t>ice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805212" y="6058159"/>
            <a:ext cx="826032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Supplemental </a:t>
            </a:r>
            <a:r>
              <a:rPr lang="en-US" sz="1400"/>
              <a:t>Figure </a:t>
            </a:r>
            <a:r>
              <a:rPr lang="en-US" sz="1400" smtClean="0"/>
              <a:t>S6 </a:t>
            </a:r>
            <a:r>
              <a:rPr lang="en-US" sz="1400" dirty="0"/>
              <a:t>Feature importance of the newly added features to the Arabidopsis and rice models. Feature importance was determined by the change of AUC-ROC after removing each feature once. Red arrows indicate the new features that were added. </a:t>
            </a:r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2506618"/>
              </p:ext>
            </p:extLst>
          </p:nvPr>
        </p:nvGraphicFramePr>
        <p:xfrm>
          <a:off x="1113876" y="1272772"/>
          <a:ext cx="7631072" cy="1925071"/>
        </p:xfrm>
        <a:graphic>
          <a:graphicData uri="http://schemas.openxmlformats.org/drawingml/2006/table">
            <a:tbl>
              <a:tblPr/>
              <a:tblGrid>
                <a:gridCol w="23847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238471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</a:tblGrid>
              <a:tr h="1925071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paralog_copy_number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TF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specialized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CE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normalized_nonsyn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network_weight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receptor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hormone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carbohydrate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inorganic_nutrient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macromolecule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transporter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cofactor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essential_gene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nonsyn_deleterious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kinase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fatty_acid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splice_site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energy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TFBS_indel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other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stop_gained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redox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detoxification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stop_lost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 err="1"/>
                        <a:t>is_amino_acid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nucleotides_metabolism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start_lost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percent_absence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TFBS_snp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CE_indel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00" b="1" dirty="0" err="1"/>
                        <a:t>is_start_garined</a:t>
                      </a:r>
                      <a:endParaRPr lang="en-US" sz="1000" b="1" dirty="0"/>
                    </a:p>
                  </a:txBody>
                  <a:tcPr marL="2967" marR="2967" marT="2967" marB="0" vert="vert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cxnSp>
        <p:nvCxnSpPr>
          <p:cNvPr id="6" name="Straight Connector 5"/>
          <p:cNvCxnSpPr/>
          <p:nvPr/>
        </p:nvCxnSpPr>
        <p:spPr>
          <a:xfrm>
            <a:off x="1099278" y="868800"/>
            <a:ext cx="7631072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1051594" y="3597625"/>
            <a:ext cx="7631072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9155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4019</TotalTime>
  <Words>119</Words>
  <Application>Microsoft Macintosh PowerPoint</Application>
  <PresentationFormat>Letter Paper (8.5x11 in)</PresentationFormat>
  <Paragraphs>7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rnegie Institution for Scien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ue Rhee</dc:creator>
  <cp:lastModifiedBy>Fan Lin</cp:lastModifiedBy>
  <cp:revision>1963</cp:revision>
  <cp:lastPrinted>2018-09-16T11:06:18Z</cp:lastPrinted>
  <dcterms:created xsi:type="dcterms:W3CDTF">2015-03-24T14:56:08Z</dcterms:created>
  <dcterms:modified xsi:type="dcterms:W3CDTF">2020-02-03T04:45:02Z</dcterms:modified>
</cp:coreProperties>
</file>